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3150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29/3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9679443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29/3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398629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29/3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77608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29/3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056006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29/3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224812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29/3/2026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765024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29/3/2026</a:t>
            </a:fld>
            <a:endParaRPr lang="es-A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8882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29/3/2026</a:t>
            </a:fld>
            <a:endParaRPr lang="es-A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497119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29/3/2026</a:t>
            </a:fld>
            <a:endParaRPr lang="es-A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443936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29/3/2026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695701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29/3/2026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262484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89DBA35-C803-409F-BB36-B91EE33C9E73}" type="datetimeFigureOut">
              <a:rPr lang="es-AR" smtClean="0"/>
              <a:t>29/3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524005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B7A7A0DA-54F5-45D5-F8F3-27B5C10A29C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237729"/>
              </p:ext>
            </p:extLst>
          </p:nvPr>
        </p:nvGraphicFramePr>
        <p:xfrm>
          <a:off x="238125" y="5694877"/>
          <a:ext cx="6362700" cy="37528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362700">
                  <a:extLst>
                    <a:ext uri="{9D8B030D-6E8A-4147-A177-3AD203B41FA5}">
                      <a16:colId xmlns:a16="http://schemas.microsoft.com/office/drawing/2014/main" val="363730006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>
                          <a:solidFill>
                            <a:srgbClr val="FF0000"/>
                          </a:solidFill>
                          <a:effectLst/>
                          <a:latin typeface="Inter"/>
                        </a:rPr>
                        <a:t>* </a:t>
                      </a:r>
                      <a:r>
                        <a:rPr lang="en-US" sz="1200" b="0" i="0" dirty="0">
                          <a:solidFill>
                            <a:srgbClr val="09090B"/>
                          </a:solidFill>
                          <a:effectLst/>
                          <a:latin typeface="Inter"/>
                        </a:rPr>
                        <a:t>These rats comprise the same subgroup as VEH Group 1 (age 22 weeks).</a:t>
                      </a:r>
                      <a:br>
                        <a:rPr lang="en-US" sz="1200" dirty="0"/>
                      </a:br>
                      <a:r>
                        <a:rPr lang="en-US" sz="1200" b="0" i="0" dirty="0">
                          <a:solidFill>
                            <a:srgbClr val="FF0000"/>
                          </a:solidFill>
                          <a:effectLst/>
                          <a:latin typeface="Inter"/>
                        </a:rPr>
                        <a:t>** </a:t>
                      </a:r>
                      <a:r>
                        <a:rPr lang="en-US" sz="1200" b="0" i="0" dirty="0">
                          <a:solidFill>
                            <a:srgbClr val="09090B"/>
                          </a:solidFill>
                          <a:effectLst/>
                          <a:latin typeface="Inter"/>
                        </a:rPr>
                        <a:t>These rats comprise the same subgroups as VEH Group 3 (ages 28 and 34 weeks, respectively).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7851328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8E20B98-F72A-6EA0-46F6-D259249FFFDC}"/>
              </a:ext>
            </a:extLst>
          </p:cNvPr>
          <p:cNvSpPr txBox="1"/>
          <p:nvPr/>
        </p:nvSpPr>
        <p:spPr>
          <a:xfrm>
            <a:off x="217241" y="224683"/>
            <a:ext cx="63835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3D3D3D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3: </a:t>
            </a:r>
            <a:r>
              <a:rPr lang="en-US" sz="1400" dirty="0">
                <a:solidFill>
                  <a:srgbClr val="3D3D3D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eans of body</a:t>
            </a:r>
            <a:r>
              <a:rPr lang="en-US" sz="1400" dirty="0">
                <a:solidFill>
                  <a:srgbClr val="3D3D3D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</a:t>
            </a:r>
            <a:r>
              <a:rPr lang="en-US" sz="1400" dirty="0">
                <a:solidFill>
                  <a:srgbClr val="3D3D3D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ight (BW) ± standard deviation (SD</a:t>
            </a:r>
            <a:r>
              <a:rPr lang="en-US" sz="1400" dirty="0">
                <a:solidFill>
                  <a:srgbClr val="3D3D3D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400" dirty="0">
                <a:solidFill>
                  <a:srgbClr val="3D3D3D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the female rice rats by treatment, age at initiation, and duration of treatments in Study </a:t>
            </a:r>
            <a:r>
              <a:rPr lang="en-US" sz="1400" dirty="0">
                <a:solidFill>
                  <a:srgbClr val="3D3D3D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s-A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7CC84FD-1648-64F6-A7C7-2FE1E552F0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8411" y="902052"/>
            <a:ext cx="5943600" cy="46386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4846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0</TotalTime>
  <Words>73</Words>
  <Application>Microsoft Office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Inter</vt:lpstr>
      <vt:lpstr>Times New Roman</vt:lpstr>
      <vt:lpstr>Office Theme</vt:lpstr>
      <vt:lpstr>PowerPoint Presentation</vt:lpstr>
    </vt:vector>
  </TitlesOfParts>
  <Company>University of Florida Academic Health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guirre,Jose I</dc:creator>
  <cp:lastModifiedBy>Aguirre,Jose I</cp:lastModifiedBy>
  <cp:revision>4</cp:revision>
  <dcterms:created xsi:type="dcterms:W3CDTF">2026-03-25T17:28:21Z</dcterms:created>
  <dcterms:modified xsi:type="dcterms:W3CDTF">2026-03-29T17:52:27Z</dcterms:modified>
</cp:coreProperties>
</file>